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70" r:id="rId2"/>
    <p:sldId id="271" r:id="rId3"/>
    <p:sldId id="268" r:id="rId4"/>
    <p:sldId id="269" r:id="rId5"/>
    <p:sldId id="272" r:id="rId6"/>
    <p:sldId id="273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565" autoAdjust="0"/>
    <p:restoredTop sz="94653"/>
  </p:normalViewPr>
  <p:slideViewPr>
    <p:cSldViewPr snapToGrid="0">
      <p:cViewPr>
        <p:scale>
          <a:sx n="70" d="100"/>
          <a:sy n="70" d="100"/>
        </p:scale>
        <p:origin x="1022" y="49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1E09B59-E799-4A53-A9A7-FC9D4C39F065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4508993-E285-41E1-9959-418ACB7061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72671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Values are n or n (%) unless otherwise indicated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4508993-E285-41E1-9959-418ACB70611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29474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Values are n or n (%) unless otherwise indicated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4508993-E285-41E1-9959-418ACB70611D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687489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Values are n or n (%) unless otherwise indicated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4508993-E285-41E1-9959-418ACB70611D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832538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Values are n or n (%) unless otherwise </a:t>
            </a:r>
            <a:r>
              <a:rPr lang="en-US"/>
              <a:t>indicated.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4508993-E285-41E1-9959-418ACB70611D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75942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Values are n or n (%) unless otherwise indicated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4508993-E285-41E1-9959-418ACB70611D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7921268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Values are n or n (%) unless otherwise indicated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4508993-E285-41E1-9959-418ACB70611D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16862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27A766-17BA-4D76-BEF3-CF7B5641D11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0D199C5-9EB4-435F-93A4-CA0FB28ECC7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FC00DF-6F7A-4BED-AF70-E9B14BE3AC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6AB73-4110-4733-A9F2-A4A44B8FD0A5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336244-1B73-42ED-8EF7-F26140B281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FBFD8E-7596-43B5-A041-66CD0E1F0F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E867A-D251-450F-9943-17EFB769FC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53595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F90D77-6E40-4C7C-BFA7-5F81027619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222AB8C-66B8-4DA4-92E1-06DFFB5EC8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3B7507-5825-40AF-A6D6-2CF8534292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6AB73-4110-4733-A9F2-A4A44B8FD0A5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649A5B-D3D9-47C7-8170-A28B32F5C5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96C180-35E9-4899-A853-96F45D413D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E867A-D251-450F-9943-17EFB769FC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857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6B7343E-0202-4F00-AC68-F09667BC2FD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1D59F68-717F-4913-B6CD-577915D276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CDCF45-CD3D-4CD9-98A3-0D10E0FA33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6AB73-4110-4733-A9F2-A4A44B8FD0A5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C6470C-B2A2-41E2-B9C0-5E5DA3232B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9B5810-FC13-4C73-99FA-D8095136D7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E867A-D251-450F-9943-17EFB769FC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81558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7D8272-7261-4262-A75F-BF338CDA63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ACBD7F5-32FD-43BA-A532-C668D40024A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25A976-B415-4FA3-92E3-6A779E6FCF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6AB73-4110-4733-A9F2-A4A44B8FD0A5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8F6217-890A-4EBB-BE1B-242258F6C6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F3A75D-0743-4FC7-AF73-7EBF8D0EB8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E867A-D251-450F-9943-17EFB769FC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16545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B57C26-6C97-4BDD-88CB-9C16F2A13A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929E43D-3384-46D4-8511-C602E4AC20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995AB5-014C-41D4-ABDB-ED4D72792C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6AB73-4110-4733-A9F2-A4A44B8FD0A5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32CD61-291E-4B9C-8DC6-AB38E2002F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370F77-F10C-414C-9A26-4F961D399A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E867A-D251-450F-9943-17EFB769FC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42294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FF9289-AAA1-4A3C-8363-8A8A6B9B5A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C61322D-B163-4C03-B767-07C4AD96787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284C6B8-70C2-487C-B3D0-E4B9A77E039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6B4C3CF-4A77-4302-B883-B7A140DCF8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6AB73-4110-4733-A9F2-A4A44B8FD0A5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996E5EC-847F-46E7-976D-D90FC336F3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452731D-74E8-49C4-9412-691328C4DD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E867A-D251-450F-9943-17EFB769FC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97678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8FF5E9-7009-46DE-8968-F0963E0839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3EA9F00-528B-49DC-BCC6-89F6B3AB4F3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AEB2E1A-41CA-4483-B59B-E30B9C9635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D6A40BE-3F36-4D4F-9411-497F72A8DF8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AB961AF-E66B-402A-A302-ED0E3EE1B1C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1D20681-89D5-4BC3-B897-C2A00E4D58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6AB73-4110-4733-A9F2-A4A44B8FD0A5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057FD78-4BCC-4374-9EEF-D7D291200E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3EF6232-6DC5-4883-A124-10D550A768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E867A-D251-450F-9943-17EFB769FC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4686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093925-2AEB-4867-928C-C6F6A23149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ECD4CEA-451A-42A8-84CB-89EC282760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6AB73-4110-4733-A9F2-A4A44B8FD0A5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41D512B-D6D8-436D-AB51-7BE43CF08A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45C8DA5-60D3-4E07-A7DB-BEA73DE14F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E867A-D251-450F-9943-17EFB769FC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08659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57C80CC-F60E-4F96-975A-B7C2D89264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6AB73-4110-4733-A9F2-A4A44B8FD0A5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F8A23FF-6E1C-4E91-8A40-C81549BCDF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95A824D-1A5C-4EED-A096-1592A04AA3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E867A-D251-450F-9943-17EFB769FC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87369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DA8565-D0D1-44B8-AFED-76DE1717B3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CF6B1B-7BDB-4248-AC41-5C267403429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4D16E3C-E431-400F-9E59-69852919F8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4F9FB58-6ACD-4B7C-BBA1-219019236A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6AB73-4110-4733-A9F2-A4A44B8FD0A5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F87A048-3765-4393-B850-E23B2E3D6D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E608EE-D373-433E-A5B8-3DD7E14D8A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E867A-D251-450F-9943-17EFB769FC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66142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1895DB-00CD-4AB8-810C-BB75CF5EED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40E2184-B211-44CB-87AF-78FCFD2C2DD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86E0CD1-E92F-4891-AC39-5097F49DCA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C2A5683-C573-4C1E-A0AC-A9E986BE75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C6AB73-4110-4733-A9F2-A4A44B8FD0A5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BBBD0BC-4F73-477A-841A-8E467E92EA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DAFA612-E0FC-42B6-9B28-7922862BD6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CE867A-D251-450F-9943-17EFB769FC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3892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542D917-29A4-4ACE-B218-2DD537E840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2CF55AA-F196-4E78-B923-3235CE9FA3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9E1ABC-F944-461C-854A-78532ACB708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C6AB73-4110-4733-A9F2-A4A44B8FD0A5}" type="datetimeFigureOut">
              <a:rPr lang="en-US" smtClean="0"/>
              <a:t>12/17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A88061-A0B4-402C-9C71-218B4450EE1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D5D7DD-3FA2-4ECB-8FD5-94CB49554D6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CE867A-D251-450F-9943-17EFB769FC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86560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1">
            <a:extLst>
              <a:ext uri="{FF2B5EF4-FFF2-40B4-BE49-F238E27FC236}">
                <a16:creationId xmlns:a16="http://schemas.microsoft.com/office/drawing/2014/main" id="{A50BDAEB-0576-41EA-B780-A6DB8D0F8614}"/>
              </a:ext>
            </a:extLst>
          </p:cNvPr>
          <p:cNvSpPr txBox="1"/>
          <p:nvPr/>
        </p:nvSpPr>
        <p:spPr>
          <a:xfrm>
            <a:off x="409322" y="235975"/>
            <a:ext cx="22453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GB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Supplemental Table 1.</a:t>
            </a:r>
          </a:p>
        </p:txBody>
      </p:sp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61F0535F-338B-41CF-8725-529D9D78919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69077257"/>
              </p:ext>
            </p:extLst>
          </p:nvPr>
        </p:nvGraphicFramePr>
        <p:xfrm>
          <a:off x="3429000" y="605308"/>
          <a:ext cx="4371180" cy="5782452"/>
        </p:xfrm>
        <a:graphic>
          <a:graphicData uri="http://schemas.openxmlformats.org/drawingml/2006/table">
            <a:tbl>
              <a:tblPr/>
              <a:tblGrid>
                <a:gridCol w="1564990">
                  <a:extLst>
                    <a:ext uri="{9D8B030D-6E8A-4147-A177-3AD203B41FA5}">
                      <a16:colId xmlns:a16="http://schemas.microsoft.com/office/drawing/2014/main" val="3110886189"/>
                    </a:ext>
                  </a:extLst>
                </a:gridCol>
                <a:gridCol w="982167">
                  <a:extLst>
                    <a:ext uri="{9D8B030D-6E8A-4147-A177-3AD203B41FA5}">
                      <a16:colId xmlns:a16="http://schemas.microsoft.com/office/drawing/2014/main" val="779709647"/>
                    </a:ext>
                  </a:extLst>
                </a:gridCol>
                <a:gridCol w="712340">
                  <a:extLst>
                    <a:ext uri="{9D8B030D-6E8A-4147-A177-3AD203B41FA5}">
                      <a16:colId xmlns:a16="http://schemas.microsoft.com/office/drawing/2014/main" val="3865453830"/>
                    </a:ext>
                  </a:extLst>
                </a:gridCol>
                <a:gridCol w="1111683">
                  <a:extLst>
                    <a:ext uri="{9D8B030D-6E8A-4147-A177-3AD203B41FA5}">
                      <a16:colId xmlns:a16="http://schemas.microsoft.com/office/drawing/2014/main" val="3233017267"/>
                    </a:ext>
                  </a:extLst>
                </a:gridCol>
              </a:tblGrid>
              <a:tr h="148295">
                <a:tc gridSpan="4">
                  <a:txBody>
                    <a:bodyPr/>
                    <a:lstStyle/>
                    <a:p>
                      <a:pPr algn="l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tails of Cardiac related events due to Elotuzumab</a:t>
                      </a:r>
                    </a:p>
                    <a:p>
                      <a:pPr algn="l" fontAlgn="ctr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05951699"/>
                  </a:ext>
                </a:extLst>
              </a:tr>
              <a:tr h="27588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number of reported Aes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rial Fibrillation 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diac Failure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ronary Artery Disease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9720438"/>
                  </a:ext>
                </a:extLst>
              </a:tr>
              <a:tr h="15307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x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90589976"/>
                  </a:ext>
                </a:extLst>
              </a:tr>
              <a:tr h="15307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79369182"/>
                  </a:ext>
                </a:extLst>
              </a:tr>
              <a:tr h="15307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56115294"/>
                  </a:ext>
                </a:extLst>
              </a:tr>
              <a:tr h="15307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t Specified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94293010"/>
                  </a:ext>
                </a:extLst>
              </a:tr>
              <a:tr h="15307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 in years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52101106"/>
                  </a:ext>
                </a:extLst>
              </a:tr>
              <a:tr h="15307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-64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72380366"/>
                  </a:ext>
                </a:extLst>
              </a:tr>
              <a:tr h="15307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-85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3878059"/>
                  </a:ext>
                </a:extLst>
              </a:tr>
              <a:tr h="15307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+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82004071"/>
                  </a:ext>
                </a:extLst>
              </a:tr>
              <a:tr h="15307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t Specified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7506894"/>
                  </a:ext>
                </a:extLst>
              </a:tr>
              <a:tr h="15307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ype of reaction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8344512"/>
                  </a:ext>
                </a:extLst>
              </a:tr>
              <a:tr h="15307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ious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39460073"/>
                  </a:ext>
                </a:extLst>
              </a:tr>
              <a:tr h="15307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serious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1694833"/>
                  </a:ext>
                </a:extLst>
              </a:tr>
              <a:tr h="16424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utcome reported per AE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62308958"/>
                  </a:ext>
                </a:extLst>
              </a:tr>
              <a:tr h="15307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ospitalization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1637043"/>
                  </a:ext>
                </a:extLst>
              </a:tr>
              <a:tr h="15307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fe-threatening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45378387"/>
                  </a:ext>
                </a:extLst>
              </a:tr>
              <a:tr h="15307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serious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28894665"/>
                  </a:ext>
                </a:extLst>
              </a:tr>
              <a:tr h="15307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ath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94012379"/>
                  </a:ext>
                </a:extLst>
              </a:tr>
              <a:tr h="15307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her Outcome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1110137"/>
                  </a:ext>
                </a:extLst>
              </a:tr>
              <a:tr h="15307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abled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08994525"/>
                  </a:ext>
                </a:extLst>
              </a:tr>
              <a:tr h="15307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genital Anomaly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54713931"/>
                  </a:ext>
                </a:extLst>
              </a:tr>
              <a:tr h="28702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utcome counts by year received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72135522"/>
                  </a:ext>
                </a:extLst>
              </a:tr>
              <a:tr h="15307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0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56046672"/>
                  </a:ext>
                </a:extLst>
              </a:tr>
              <a:tr h="15307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1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79858538"/>
                  </a:ext>
                </a:extLst>
              </a:tr>
              <a:tr h="15307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2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24692529"/>
                  </a:ext>
                </a:extLst>
              </a:tr>
              <a:tr h="15307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3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14498246"/>
                  </a:ext>
                </a:extLst>
              </a:tr>
              <a:tr h="15307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4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04448983"/>
                  </a:ext>
                </a:extLst>
              </a:tr>
              <a:tr h="15307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5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2832686"/>
                  </a:ext>
                </a:extLst>
              </a:tr>
              <a:tr h="15307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6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23760239"/>
                  </a:ext>
                </a:extLst>
              </a:tr>
              <a:tr h="15307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7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81140877"/>
                  </a:ext>
                </a:extLst>
              </a:tr>
              <a:tr h="15307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8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19868882"/>
                  </a:ext>
                </a:extLst>
              </a:tr>
              <a:tr h="15307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9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53730763"/>
                  </a:ext>
                </a:extLst>
              </a:tr>
              <a:tr h="15307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20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31378973"/>
                  </a:ext>
                </a:extLst>
              </a:tr>
              <a:tr h="15307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21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5049" marR="5049" marT="504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338879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388124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1">
            <a:extLst>
              <a:ext uri="{FF2B5EF4-FFF2-40B4-BE49-F238E27FC236}">
                <a16:creationId xmlns:a16="http://schemas.microsoft.com/office/drawing/2014/main" id="{14299985-858C-414C-80D5-EEDC223D6AA9}"/>
              </a:ext>
            </a:extLst>
          </p:cNvPr>
          <p:cNvSpPr txBox="1"/>
          <p:nvPr/>
        </p:nvSpPr>
        <p:spPr>
          <a:xfrm>
            <a:off x="153683" y="245496"/>
            <a:ext cx="22453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GB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Supplemental Table 2.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E83BE615-F44E-4F57-8B2F-BAF06942C87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67770550"/>
              </p:ext>
            </p:extLst>
          </p:nvPr>
        </p:nvGraphicFramePr>
        <p:xfrm>
          <a:off x="3379153" y="967239"/>
          <a:ext cx="4610962" cy="5088330"/>
        </p:xfrm>
        <a:graphic>
          <a:graphicData uri="http://schemas.openxmlformats.org/drawingml/2006/table">
            <a:tbl>
              <a:tblPr/>
              <a:tblGrid>
                <a:gridCol w="1747795">
                  <a:extLst>
                    <a:ext uri="{9D8B030D-6E8A-4147-A177-3AD203B41FA5}">
                      <a16:colId xmlns:a16="http://schemas.microsoft.com/office/drawing/2014/main" val="1229790276"/>
                    </a:ext>
                  </a:extLst>
                </a:gridCol>
                <a:gridCol w="873898">
                  <a:extLst>
                    <a:ext uri="{9D8B030D-6E8A-4147-A177-3AD203B41FA5}">
                      <a16:colId xmlns:a16="http://schemas.microsoft.com/office/drawing/2014/main" val="4126830807"/>
                    </a:ext>
                  </a:extLst>
                </a:gridCol>
                <a:gridCol w="758912">
                  <a:extLst>
                    <a:ext uri="{9D8B030D-6E8A-4147-A177-3AD203B41FA5}">
                      <a16:colId xmlns:a16="http://schemas.microsoft.com/office/drawing/2014/main" val="3299241862"/>
                    </a:ext>
                  </a:extLst>
                </a:gridCol>
                <a:gridCol w="1230357">
                  <a:extLst>
                    <a:ext uri="{9D8B030D-6E8A-4147-A177-3AD203B41FA5}">
                      <a16:colId xmlns:a16="http://schemas.microsoft.com/office/drawing/2014/main" val="11669328"/>
                    </a:ext>
                  </a:extLst>
                </a:gridCol>
              </a:tblGrid>
              <a:tr h="145613"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tails of Cardiac related events due to Ixazomib</a:t>
                      </a:r>
                    </a:p>
                    <a:p>
                      <a:pPr algn="l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49949768"/>
                  </a:ext>
                </a:extLst>
              </a:tr>
              <a:tr h="2692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number of reported AEs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rial Fibrillation 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diac Failure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ronary Artery Disease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7038922"/>
                  </a:ext>
                </a:extLst>
              </a:tr>
              <a:tr h="145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x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13474691"/>
                  </a:ext>
                </a:extLst>
              </a:tr>
              <a:tr h="145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2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9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0675830"/>
                  </a:ext>
                </a:extLst>
              </a:tr>
              <a:tr h="145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1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6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2213681"/>
                  </a:ext>
                </a:extLst>
              </a:tr>
              <a:tr h="145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t Specified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99373795"/>
                  </a:ext>
                </a:extLst>
              </a:tr>
              <a:tr h="145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 in years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96988869"/>
                  </a:ext>
                </a:extLst>
              </a:tr>
              <a:tr h="145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-64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9003280"/>
                  </a:ext>
                </a:extLst>
              </a:tr>
              <a:tr h="145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-85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5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39860277"/>
                  </a:ext>
                </a:extLst>
              </a:tr>
              <a:tr h="145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+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11102153"/>
                  </a:ext>
                </a:extLst>
              </a:tr>
              <a:tr h="145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t Specified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7168506"/>
                  </a:ext>
                </a:extLst>
              </a:tr>
              <a:tr h="145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ype of reaction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18628235"/>
                  </a:ext>
                </a:extLst>
              </a:tr>
              <a:tr h="145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ious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2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9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57679921"/>
                  </a:ext>
                </a:extLst>
              </a:tr>
              <a:tr h="145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serious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4269046"/>
                  </a:ext>
                </a:extLst>
              </a:tr>
              <a:tr h="156231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utcome reported per AE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3124604"/>
                  </a:ext>
                </a:extLst>
              </a:tr>
              <a:tr h="145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ospitalization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5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8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7894493"/>
                  </a:ext>
                </a:extLst>
              </a:tr>
              <a:tr h="145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fe-threatening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6184555"/>
                  </a:ext>
                </a:extLst>
              </a:tr>
              <a:tr h="145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serious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44936093"/>
                  </a:ext>
                </a:extLst>
              </a:tr>
              <a:tr h="145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ath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40785235"/>
                  </a:ext>
                </a:extLst>
              </a:tr>
              <a:tr h="145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her Outcome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9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2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42574711"/>
                  </a:ext>
                </a:extLst>
              </a:tr>
              <a:tr h="145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abled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80308527"/>
                  </a:ext>
                </a:extLst>
              </a:tr>
              <a:tr h="1516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genital Anomaly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89187287"/>
                  </a:ext>
                </a:extLst>
              </a:tr>
              <a:tr h="26922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utcome counts by year received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75895212"/>
                  </a:ext>
                </a:extLst>
              </a:tr>
              <a:tr h="145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3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59069378"/>
                  </a:ext>
                </a:extLst>
              </a:tr>
              <a:tr h="145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4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84205832"/>
                  </a:ext>
                </a:extLst>
              </a:tr>
              <a:tr h="145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5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16236402"/>
                  </a:ext>
                </a:extLst>
              </a:tr>
              <a:tr h="145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6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9596716"/>
                  </a:ext>
                </a:extLst>
              </a:tr>
              <a:tr h="145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7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1153109"/>
                  </a:ext>
                </a:extLst>
              </a:tr>
              <a:tr h="145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8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2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68092696"/>
                  </a:ext>
                </a:extLst>
              </a:tr>
              <a:tr h="145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9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4365207"/>
                  </a:ext>
                </a:extLst>
              </a:tr>
              <a:tr h="145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20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8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5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8244147"/>
                  </a:ext>
                </a:extLst>
              </a:tr>
              <a:tr h="145613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21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2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</a:t>
                      </a:r>
                    </a:p>
                  </a:txBody>
                  <a:tcPr marL="5622" marR="5622" marT="562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6469376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806926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">
            <a:extLst>
              <a:ext uri="{FF2B5EF4-FFF2-40B4-BE49-F238E27FC236}">
                <a16:creationId xmlns:a16="http://schemas.microsoft.com/office/drawing/2014/main" id="{E54F5022-8707-4B47-A5D1-3497C1C26394}"/>
              </a:ext>
            </a:extLst>
          </p:cNvPr>
          <p:cNvSpPr txBox="1"/>
          <p:nvPr/>
        </p:nvSpPr>
        <p:spPr>
          <a:xfrm>
            <a:off x="694457" y="312045"/>
            <a:ext cx="22453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GB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Supplemental Table 3.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976524D1-A851-4BE4-9EE0-8E523FC33F8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02179326"/>
              </p:ext>
            </p:extLst>
          </p:nvPr>
        </p:nvGraphicFramePr>
        <p:xfrm>
          <a:off x="3429001" y="935449"/>
          <a:ext cx="4767943" cy="4917768"/>
        </p:xfrm>
        <a:graphic>
          <a:graphicData uri="http://schemas.openxmlformats.org/drawingml/2006/table">
            <a:tbl>
              <a:tblPr/>
              <a:tblGrid>
                <a:gridCol w="1728379">
                  <a:extLst>
                    <a:ext uri="{9D8B030D-6E8A-4147-A177-3AD203B41FA5}">
                      <a16:colId xmlns:a16="http://schemas.microsoft.com/office/drawing/2014/main" val="4118254606"/>
                    </a:ext>
                  </a:extLst>
                </a:gridCol>
                <a:gridCol w="1037028">
                  <a:extLst>
                    <a:ext uri="{9D8B030D-6E8A-4147-A177-3AD203B41FA5}">
                      <a16:colId xmlns:a16="http://schemas.microsoft.com/office/drawing/2014/main" val="637842754"/>
                    </a:ext>
                  </a:extLst>
                </a:gridCol>
                <a:gridCol w="798630">
                  <a:extLst>
                    <a:ext uri="{9D8B030D-6E8A-4147-A177-3AD203B41FA5}">
                      <a16:colId xmlns:a16="http://schemas.microsoft.com/office/drawing/2014/main" val="150531111"/>
                    </a:ext>
                  </a:extLst>
                </a:gridCol>
                <a:gridCol w="1203906">
                  <a:extLst>
                    <a:ext uri="{9D8B030D-6E8A-4147-A177-3AD203B41FA5}">
                      <a16:colId xmlns:a16="http://schemas.microsoft.com/office/drawing/2014/main" val="2560551565"/>
                    </a:ext>
                  </a:extLst>
                </a:gridCol>
              </a:tblGrid>
              <a:tr h="139752"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tails of Cardiac related events due to Daratumumab</a:t>
                      </a:r>
                    </a:p>
                    <a:p>
                      <a:pPr algn="l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26465089"/>
                  </a:ext>
                </a:extLst>
              </a:tr>
              <a:tr h="159417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number of reported AE's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rial Fibrillation 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diac Failure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ronary Artery Disease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47832494"/>
                  </a:ext>
                </a:extLst>
              </a:tr>
              <a:tr h="1530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x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52744751"/>
                  </a:ext>
                </a:extLst>
              </a:tr>
              <a:tr h="1530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3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4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4030752"/>
                  </a:ext>
                </a:extLst>
              </a:tr>
              <a:tr h="1530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8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5619094"/>
                  </a:ext>
                </a:extLst>
              </a:tr>
              <a:tr h="1530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t Specified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15719252"/>
                  </a:ext>
                </a:extLst>
              </a:tr>
              <a:tr h="164198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 in years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73828507"/>
                  </a:ext>
                </a:extLst>
              </a:tr>
              <a:tr h="1530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-64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9486870"/>
                  </a:ext>
                </a:extLst>
              </a:tr>
              <a:tr h="1530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-85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5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9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5930986"/>
                  </a:ext>
                </a:extLst>
              </a:tr>
              <a:tr h="1530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+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19782275"/>
                  </a:ext>
                </a:extLst>
              </a:tr>
              <a:tr h="1530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t Specified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7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52492530"/>
                  </a:ext>
                </a:extLst>
              </a:tr>
              <a:tr h="175358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ype of reaction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78743003"/>
                  </a:ext>
                </a:extLst>
              </a:tr>
              <a:tr h="1530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ious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1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7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4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6014"/>
                  </a:ext>
                </a:extLst>
              </a:tr>
              <a:tr h="1530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serious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63831619"/>
                  </a:ext>
                </a:extLst>
              </a:tr>
              <a:tr h="148257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utcome reported per AE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01129680"/>
                  </a:ext>
                </a:extLst>
              </a:tr>
              <a:tr h="1530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ospitalization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6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4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35562647"/>
                  </a:ext>
                </a:extLst>
              </a:tr>
              <a:tr h="1530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fe-threatening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81747752"/>
                  </a:ext>
                </a:extLst>
              </a:tr>
              <a:tr h="1530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serious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59845033"/>
                  </a:ext>
                </a:extLst>
              </a:tr>
              <a:tr h="1530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ath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02249670"/>
                  </a:ext>
                </a:extLst>
              </a:tr>
              <a:tr h="1530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her Outcome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4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9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728416"/>
                  </a:ext>
                </a:extLst>
              </a:tr>
              <a:tr h="1530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abled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17481666"/>
                  </a:ext>
                </a:extLst>
              </a:tr>
              <a:tr h="1530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genital Anomaly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6434223"/>
                  </a:ext>
                </a:extLst>
              </a:tr>
              <a:tr h="286949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utcome counts by year received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44472080"/>
                  </a:ext>
                </a:extLst>
              </a:tr>
              <a:tr h="1530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5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04815515"/>
                  </a:ext>
                </a:extLst>
              </a:tr>
              <a:tr h="1530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6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01543151"/>
                  </a:ext>
                </a:extLst>
              </a:tr>
              <a:tr h="1530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7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690407"/>
                  </a:ext>
                </a:extLst>
              </a:tr>
              <a:tr h="1530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8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50754348"/>
                  </a:ext>
                </a:extLst>
              </a:tr>
              <a:tr h="1530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9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77477711"/>
                  </a:ext>
                </a:extLst>
              </a:tr>
              <a:tr h="1530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20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02329509"/>
                  </a:ext>
                </a:extLst>
              </a:tr>
              <a:tr h="15304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21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</a:t>
                      </a:r>
                    </a:p>
                  </a:txBody>
                  <a:tcPr marL="5829" marR="5829" marT="58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350125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465645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4CD57EF0-FA7C-496B-8912-A9465B5F9C8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45156029"/>
              </p:ext>
            </p:extLst>
          </p:nvPr>
        </p:nvGraphicFramePr>
        <p:xfrm>
          <a:off x="3755571" y="922106"/>
          <a:ext cx="5421085" cy="5358604"/>
        </p:xfrm>
        <a:graphic>
          <a:graphicData uri="http://schemas.openxmlformats.org/drawingml/2006/table">
            <a:tbl>
              <a:tblPr/>
              <a:tblGrid>
                <a:gridCol w="2024240">
                  <a:extLst>
                    <a:ext uri="{9D8B030D-6E8A-4147-A177-3AD203B41FA5}">
                      <a16:colId xmlns:a16="http://schemas.microsoft.com/office/drawing/2014/main" val="2706904016"/>
                    </a:ext>
                  </a:extLst>
                </a:gridCol>
                <a:gridCol w="1053715">
                  <a:extLst>
                    <a:ext uri="{9D8B030D-6E8A-4147-A177-3AD203B41FA5}">
                      <a16:colId xmlns:a16="http://schemas.microsoft.com/office/drawing/2014/main" val="563311643"/>
                    </a:ext>
                  </a:extLst>
                </a:gridCol>
                <a:gridCol w="970529">
                  <a:extLst>
                    <a:ext uri="{9D8B030D-6E8A-4147-A177-3AD203B41FA5}">
                      <a16:colId xmlns:a16="http://schemas.microsoft.com/office/drawing/2014/main" val="158708778"/>
                    </a:ext>
                  </a:extLst>
                </a:gridCol>
                <a:gridCol w="1372601">
                  <a:extLst>
                    <a:ext uri="{9D8B030D-6E8A-4147-A177-3AD203B41FA5}">
                      <a16:colId xmlns:a16="http://schemas.microsoft.com/office/drawing/2014/main" val="1598538457"/>
                    </a:ext>
                  </a:extLst>
                </a:gridCol>
              </a:tblGrid>
              <a:tr h="141919"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tails of Cardiac related events due to Panobinostat</a:t>
                      </a:r>
                    </a:p>
                    <a:p>
                      <a:pPr algn="l" fontAlgn="b"/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08523948"/>
                  </a:ext>
                </a:extLst>
              </a:tr>
              <a:tr h="23764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number of reported AE's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rial Fibrillation 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diac Failure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ronary Artery Disease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78511705"/>
                  </a:ext>
                </a:extLst>
              </a:tr>
              <a:tr h="1419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x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85039915"/>
                  </a:ext>
                </a:extLst>
              </a:tr>
              <a:tr h="1419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75824831"/>
                  </a:ext>
                </a:extLst>
              </a:tr>
              <a:tr h="1419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93513754"/>
                  </a:ext>
                </a:extLst>
              </a:tr>
              <a:tr h="1419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t Specified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4969659"/>
                  </a:ext>
                </a:extLst>
              </a:tr>
              <a:tr h="1419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 in years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96659082"/>
                  </a:ext>
                </a:extLst>
              </a:tr>
              <a:tr h="1419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 to 17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1063746"/>
                  </a:ext>
                </a:extLst>
              </a:tr>
              <a:tr h="1419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-64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052245"/>
                  </a:ext>
                </a:extLst>
              </a:tr>
              <a:tr h="1419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-85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22987058"/>
                  </a:ext>
                </a:extLst>
              </a:tr>
              <a:tr h="1419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+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0322802"/>
                  </a:ext>
                </a:extLst>
              </a:tr>
              <a:tr h="1419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t Specified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53739097"/>
                  </a:ext>
                </a:extLst>
              </a:tr>
              <a:tr h="144904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ype of reaction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40693203"/>
                  </a:ext>
                </a:extLst>
              </a:tr>
              <a:tr h="1419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ious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58119920"/>
                  </a:ext>
                </a:extLst>
              </a:tr>
              <a:tr h="1419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serious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13017923"/>
                  </a:ext>
                </a:extLst>
              </a:tr>
              <a:tr h="1419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utcome reported per AE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94793371"/>
                  </a:ext>
                </a:extLst>
              </a:tr>
              <a:tr h="1419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ospitalization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3511401"/>
                  </a:ext>
                </a:extLst>
              </a:tr>
              <a:tr h="1419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fe-threatening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53002393"/>
                  </a:ext>
                </a:extLst>
              </a:tr>
              <a:tr h="1419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serious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4911735"/>
                  </a:ext>
                </a:extLst>
              </a:tr>
              <a:tr h="1419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ath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46965686"/>
                  </a:ext>
                </a:extLst>
              </a:tr>
              <a:tr h="1419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her Outcome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58340784"/>
                  </a:ext>
                </a:extLst>
              </a:tr>
              <a:tr h="1419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abled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10079707"/>
                  </a:ext>
                </a:extLst>
              </a:tr>
              <a:tr h="1419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genital Anomaly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89500012"/>
                  </a:ext>
                </a:extLst>
              </a:tr>
              <a:tr h="26083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utcome counts by year received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66036690"/>
                  </a:ext>
                </a:extLst>
              </a:tr>
              <a:tr h="1419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1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6920665"/>
                  </a:ext>
                </a:extLst>
              </a:tr>
              <a:tr h="1419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2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07007859"/>
                  </a:ext>
                </a:extLst>
              </a:tr>
              <a:tr h="1419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3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86565206"/>
                  </a:ext>
                </a:extLst>
              </a:tr>
              <a:tr h="1419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4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35746625"/>
                  </a:ext>
                </a:extLst>
              </a:tr>
              <a:tr h="1419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5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32320490"/>
                  </a:ext>
                </a:extLst>
              </a:tr>
              <a:tr h="1419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6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5346269"/>
                  </a:ext>
                </a:extLst>
              </a:tr>
              <a:tr h="1419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7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61670368"/>
                  </a:ext>
                </a:extLst>
              </a:tr>
              <a:tr h="1419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8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80144372"/>
                  </a:ext>
                </a:extLst>
              </a:tr>
              <a:tr h="1419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9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16618658"/>
                  </a:ext>
                </a:extLst>
              </a:tr>
              <a:tr h="1419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20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07855677"/>
                  </a:ext>
                </a:extLst>
              </a:tr>
              <a:tr h="14191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21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4952" marR="4952" marT="4952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67124772"/>
                  </a:ext>
                </a:extLst>
              </a:tr>
            </a:tbl>
          </a:graphicData>
        </a:graphic>
      </p:graphicFrame>
      <p:sp>
        <p:nvSpPr>
          <p:cNvPr id="7" name="TextBox 1">
            <a:extLst>
              <a:ext uri="{FF2B5EF4-FFF2-40B4-BE49-F238E27FC236}">
                <a16:creationId xmlns:a16="http://schemas.microsoft.com/office/drawing/2014/main" id="{A39B3E11-2BC9-4C5C-883F-CAF48965EF07}"/>
              </a:ext>
            </a:extLst>
          </p:cNvPr>
          <p:cNvSpPr txBox="1"/>
          <p:nvPr/>
        </p:nvSpPr>
        <p:spPr>
          <a:xfrm>
            <a:off x="694457" y="312045"/>
            <a:ext cx="22453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GB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Supplemental Table 4.</a:t>
            </a:r>
          </a:p>
        </p:txBody>
      </p:sp>
    </p:spTree>
    <p:extLst>
      <p:ext uri="{BB962C8B-B14F-4D97-AF65-F5344CB8AC3E}">
        <p14:creationId xmlns:p14="http://schemas.microsoft.com/office/powerpoint/2010/main" val="343443761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CCCD1167-478C-475E-ACEC-5253CFDE25F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34943199"/>
              </p:ext>
            </p:extLst>
          </p:nvPr>
        </p:nvGraphicFramePr>
        <p:xfrm>
          <a:off x="3362206" y="965657"/>
          <a:ext cx="5313708" cy="4858208"/>
        </p:xfrm>
        <a:graphic>
          <a:graphicData uri="http://schemas.openxmlformats.org/drawingml/2006/table">
            <a:tbl>
              <a:tblPr/>
              <a:tblGrid>
                <a:gridCol w="2051147">
                  <a:extLst>
                    <a:ext uri="{9D8B030D-6E8A-4147-A177-3AD203B41FA5}">
                      <a16:colId xmlns:a16="http://schemas.microsoft.com/office/drawing/2014/main" val="1681213656"/>
                    </a:ext>
                  </a:extLst>
                </a:gridCol>
                <a:gridCol w="949860">
                  <a:extLst>
                    <a:ext uri="{9D8B030D-6E8A-4147-A177-3AD203B41FA5}">
                      <a16:colId xmlns:a16="http://schemas.microsoft.com/office/drawing/2014/main" val="988833638"/>
                    </a:ext>
                  </a:extLst>
                </a:gridCol>
                <a:gridCol w="936093">
                  <a:extLst>
                    <a:ext uri="{9D8B030D-6E8A-4147-A177-3AD203B41FA5}">
                      <a16:colId xmlns:a16="http://schemas.microsoft.com/office/drawing/2014/main" val="2821003130"/>
                    </a:ext>
                  </a:extLst>
                </a:gridCol>
                <a:gridCol w="1376608">
                  <a:extLst>
                    <a:ext uri="{9D8B030D-6E8A-4147-A177-3AD203B41FA5}">
                      <a16:colId xmlns:a16="http://schemas.microsoft.com/office/drawing/2014/main" val="2637460322"/>
                    </a:ext>
                  </a:extLst>
                </a:gridCol>
              </a:tblGrid>
              <a:tr h="183362"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tails of Cardiac related events due to Belantamab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61528875"/>
                  </a:ext>
                </a:extLst>
              </a:tr>
              <a:tr h="3066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number of reported AE's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rial Fibrillation 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diac Failure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ronary Artery Disease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17083233"/>
                  </a:ext>
                </a:extLst>
              </a:tr>
              <a:tr h="183362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x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80317582"/>
                  </a:ext>
                </a:extLst>
              </a:tr>
              <a:tr h="183362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64580889"/>
                  </a:ext>
                </a:extLst>
              </a:tr>
              <a:tr h="183362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53299453"/>
                  </a:ext>
                </a:extLst>
              </a:tr>
              <a:tr h="183362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t Specified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30217263"/>
                  </a:ext>
                </a:extLst>
              </a:tr>
              <a:tr h="177632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 in years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1988872"/>
                  </a:ext>
                </a:extLst>
              </a:tr>
              <a:tr h="183362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-64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7677845"/>
                  </a:ext>
                </a:extLst>
              </a:tr>
              <a:tr h="183362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-85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08305559"/>
                  </a:ext>
                </a:extLst>
              </a:tr>
              <a:tr h="183362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+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0898460"/>
                  </a:ext>
                </a:extLst>
              </a:tr>
              <a:tr h="183362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t Specified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80372826"/>
                  </a:ext>
                </a:extLst>
              </a:tr>
              <a:tr h="1814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ype of reaction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80012206"/>
                  </a:ext>
                </a:extLst>
              </a:tr>
              <a:tr h="183362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ious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5251713"/>
                  </a:ext>
                </a:extLst>
              </a:tr>
              <a:tr h="183362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serious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5572860"/>
                  </a:ext>
                </a:extLst>
              </a:tr>
              <a:tr h="181453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utcome Reported per AE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84367316"/>
                  </a:ext>
                </a:extLst>
              </a:tr>
              <a:tr h="183362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ospitalization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15428797"/>
                  </a:ext>
                </a:extLst>
              </a:tr>
              <a:tr h="183362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fe-threatening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69690325"/>
                  </a:ext>
                </a:extLst>
              </a:tr>
              <a:tr h="183362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serious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84925109"/>
                  </a:ext>
                </a:extLst>
              </a:tr>
              <a:tr h="18336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ath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33427367"/>
                  </a:ext>
                </a:extLst>
              </a:tr>
              <a:tr h="18336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her Outcome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89763720"/>
                  </a:ext>
                </a:extLst>
              </a:tr>
              <a:tr h="18336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abled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07872928"/>
                  </a:ext>
                </a:extLst>
              </a:tr>
              <a:tr h="18336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genital Anomaly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9234356"/>
                  </a:ext>
                </a:extLst>
              </a:tr>
              <a:tr h="34380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utcome counts by year received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60909004"/>
                  </a:ext>
                </a:extLst>
              </a:tr>
              <a:tr h="18336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20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3747323"/>
                  </a:ext>
                </a:extLst>
              </a:tr>
              <a:tr h="18336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21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7010" marR="7010" marT="701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98060042"/>
                  </a:ext>
                </a:extLst>
              </a:tr>
            </a:tbl>
          </a:graphicData>
        </a:graphic>
      </p:graphicFrame>
      <p:sp>
        <p:nvSpPr>
          <p:cNvPr id="5" name="TextBox 1">
            <a:extLst>
              <a:ext uri="{FF2B5EF4-FFF2-40B4-BE49-F238E27FC236}">
                <a16:creationId xmlns:a16="http://schemas.microsoft.com/office/drawing/2014/main" id="{9A4076FB-71E0-477D-ACE7-EB76E061117C}"/>
              </a:ext>
            </a:extLst>
          </p:cNvPr>
          <p:cNvSpPr txBox="1"/>
          <p:nvPr/>
        </p:nvSpPr>
        <p:spPr>
          <a:xfrm>
            <a:off x="694457" y="312045"/>
            <a:ext cx="22453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GB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Supplemental Table 5.</a:t>
            </a:r>
          </a:p>
        </p:txBody>
      </p:sp>
    </p:spTree>
    <p:extLst>
      <p:ext uri="{BB962C8B-B14F-4D97-AF65-F5344CB8AC3E}">
        <p14:creationId xmlns:p14="http://schemas.microsoft.com/office/powerpoint/2010/main" val="355051367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FB3341E3-A94B-449C-96AC-DFBE95B040F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37290089"/>
              </p:ext>
            </p:extLst>
          </p:nvPr>
        </p:nvGraphicFramePr>
        <p:xfrm>
          <a:off x="3465846" y="1021668"/>
          <a:ext cx="5547527" cy="4814664"/>
        </p:xfrm>
        <a:graphic>
          <a:graphicData uri="http://schemas.openxmlformats.org/drawingml/2006/table">
            <a:tbl>
              <a:tblPr/>
              <a:tblGrid>
                <a:gridCol w="2104715">
                  <a:extLst>
                    <a:ext uri="{9D8B030D-6E8A-4147-A177-3AD203B41FA5}">
                      <a16:colId xmlns:a16="http://schemas.microsoft.com/office/drawing/2014/main" val="3596468519"/>
                    </a:ext>
                  </a:extLst>
                </a:gridCol>
                <a:gridCol w="1031449">
                  <a:extLst>
                    <a:ext uri="{9D8B030D-6E8A-4147-A177-3AD203B41FA5}">
                      <a16:colId xmlns:a16="http://schemas.microsoft.com/office/drawing/2014/main" val="4143970"/>
                    </a:ext>
                  </a:extLst>
                </a:gridCol>
                <a:gridCol w="961757">
                  <a:extLst>
                    <a:ext uri="{9D8B030D-6E8A-4147-A177-3AD203B41FA5}">
                      <a16:colId xmlns:a16="http://schemas.microsoft.com/office/drawing/2014/main" val="617172003"/>
                    </a:ext>
                  </a:extLst>
                </a:gridCol>
                <a:gridCol w="1449606">
                  <a:extLst>
                    <a:ext uri="{9D8B030D-6E8A-4147-A177-3AD203B41FA5}">
                      <a16:colId xmlns:a16="http://schemas.microsoft.com/office/drawing/2014/main" val="1468563570"/>
                    </a:ext>
                  </a:extLst>
                </a:gridCol>
              </a:tblGrid>
              <a:tr h="174581"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tails of Cardiac related events due to </a:t>
                      </a:r>
                      <a:r>
                        <a:rPr lang="en-US" sz="10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linexor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97297444"/>
                  </a:ext>
                </a:extLst>
              </a:tr>
              <a:tr h="294579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number of reported AE's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rial Fibrillation 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diac Failure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ronary Artery Disease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86124098"/>
                  </a:ext>
                </a:extLst>
              </a:tr>
              <a:tr h="174581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x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16278310"/>
                  </a:ext>
                </a:extLst>
              </a:tr>
              <a:tr h="174581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85393088"/>
                  </a:ext>
                </a:extLst>
              </a:tr>
              <a:tr h="174581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38802076"/>
                  </a:ext>
                </a:extLst>
              </a:tr>
              <a:tr h="174581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t Specified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6274915"/>
                  </a:ext>
                </a:extLst>
              </a:tr>
              <a:tr h="18185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 in years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11624849"/>
                  </a:ext>
                </a:extLst>
              </a:tr>
              <a:tr h="174581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-64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95168038"/>
                  </a:ext>
                </a:extLst>
              </a:tr>
              <a:tr h="174581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5-85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37827904"/>
                  </a:ext>
                </a:extLst>
              </a:tr>
              <a:tr h="174581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+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05198928"/>
                  </a:ext>
                </a:extLst>
              </a:tr>
              <a:tr h="174581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t Specified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1128843"/>
                  </a:ext>
                </a:extLst>
              </a:tr>
              <a:tr h="174581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ype of reaction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26840053"/>
                  </a:ext>
                </a:extLst>
              </a:tr>
              <a:tr h="174581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ious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96604396"/>
                  </a:ext>
                </a:extLst>
              </a:tr>
              <a:tr h="174581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serious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30889672"/>
                  </a:ext>
                </a:extLst>
              </a:tr>
              <a:tr h="17821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utcome reported per AE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38452842"/>
                  </a:ext>
                </a:extLst>
              </a:tr>
              <a:tr h="172764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ospitalization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42936905"/>
                  </a:ext>
                </a:extLst>
              </a:tr>
              <a:tr h="169126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fe-threatening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41609682"/>
                  </a:ext>
                </a:extLst>
              </a:tr>
              <a:tr h="174581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serious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69890325"/>
                  </a:ext>
                </a:extLst>
              </a:tr>
              <a:tr h="17458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ath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31970718"/>
                  </a:ext>
                </a:extLst>
              </a:tr>
              <a:tr h="17458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ther Outcome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86548471"/>
                  </a:ext>
                </a:extLst>
              </a:tr>
              <a:tr h="17458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sabled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49601500"/>
                  </a:ext>
                </a:extLst>
              </a:tr>
              <a:tr h="17458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genital Anomaly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8216880"/>
                  </a:ext>
                </a:extLst>
              </a:tr>
              <a:tr h="32650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utcome counts by year received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8EA9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61500593"/>
                  </a:ext>
                </a:extLst>
              </a:tr>
              <a:tr h="17458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19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12832559"/>
                  </a:ext>
                </a:extLst>
              </a:tr>
              <a:tr h="17458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20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23849468"/>
                  </a:ext>
                </a:extLst>
              </a:tr>
              <a:tr h="174581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21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</a:p>
                  </a:txBody>
                  <a:tcPr marL="6945" marR="6945" marT="694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18399434"/>
                  </a:ext>
                </a:extLst>
              </a:tr>
            </a:tbl>
          </a:graphicData>
        </a:graphic>
      </p:graphicFrame>
      <p:sp>
        <p:nvSpPr>
          <p:cNvPr id="5" name="TextBox 1">
            <a:extLst>
              <a:ext uri="{FF2B5EF4-FFF2-40B4-BE49-F238E27FC236}">
                <a16:creationId xmlns:a16="http://schemas.microsoft.com/office/drawing/2014/main" id="{609081BB-49E8-4D26-86BB-2A2BCBFBF404}"/>
              </a:ext>
            </a:extLst>
          </p:cNvPr>
          <p:cNvSpPr txBox="1"/>
          <p:nvPr/>
        </p:nvSpPr>
        <p:spPr>
          <a:xfrm>
            <a:off x="694457" y="312045"/>
            <a:ext cx="22453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GB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dirty="0"/>
              <a:t>Supplemental Table 6.</a:t>
            </a:r>
          </a:p>
        </p:txBody>
      </p:sp>
    </p:spTree>
    <p:extLst>
      <p:ext uri="{BB962C8B-B14F-4D97-AF65-F5344CB8AC3E}">
        <p14:creationId xmlns:p14="http://schemas.microsoft.com/office/powerpoint/2010/main" val="29318983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</TotalTime>
  <Words>993</Words>
  <Application>Microsoft Office PowerPoint</Application>
  <PresentationFormat>Widescreen</PresentationFormat>
  <Paragraphs>733</Paragraphs>
  <Slides>6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table 1</dc:title>
  <dc:creator>Al Yafeai, Zaki</dc:creator>
  <cp:lastModifiedBy>Al Yafeai, Zaki</cp:lastModifiedBy>
  <cp:revision>8</cp:revision>
  <dcterms:created xsi:type="dcterms:W3CDTF">2021-11-16T19:19:35Z</dcterms:created>
  <dcterms:modified xsi:type="dcterms:W3CDTF">2021-12-17T17:15:03Z</dcterms:modified>
</cp:coreProperties>
</file>